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4" r:id="rId2"/>
  </p:sldIdLst>
  <p:sldSz cx="9601200" cy="12801600" type="A3"/>
  <p:notesSz cx="6858000" cy="9144000"/>
  <p:defaultTextStyle>
    <a:defPPr>
      <a:defRPr lang="en-US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31"/>
    <p:restoredTop sz="94526"/>
  </p:normalViewPr>
  <p:slideViewPr>
    <p:cSldViewPr snapToGrid="0" snapToObjects="1">
      <p:cViewPr>
        <p:scale>
          <a:sx n="123" d="100"/>
          <a:sy n="123" d="100"/>
        </p:scale>
        <p:origin x="424" y="-4440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Users/user/Desktop/Kiwi-%20Metabolites/2017%20Firmness%20kosui%20tos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Users/user/Desktop/Kiwi-%20Metabolites/2017%20KOSUI%20SSC.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Users/user/Desktop/Kiwi-%20Metabolites/&#12456;&#12481;&#12524;&#12531;&#29983;&#25104;&#37327;&#12288;&#12471;&#12540;&#12488;&#12414;&#12392;&#1241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77705599300087"/>
          <c:y val="0.025634741179231"/>
          <c:w val="0.881539807524059"/>
          <c:h val="0.9337887409093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torage (2)'!$AN$4</c:f>
              <c:strCache>
                <c:ptCount val="1"/>
                <c:pt idx="0">
                  <c:v>0 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torage (2)'!$AN$11:$AN$14</c:f>
                <c:numCache>
                  <c:formatCode>General</c:formatCode>
                  <c:ptCount val="4"/>
                  <c:pt idx="0">
                    <c:v>0.302461313178095</c:v>
                  </c:pt>
                  <c:pt idx="1">
                    <c:v>2.877008053919877</c:v>
                  </c:pt>
                  <c:pt idx="2">
                    <c:v>0.302461313178095</c:v>
                  </c:pt>
                  <c:pt idx="3">
                    <c:v>2.877008053919877</c:v>
                  </c:pt>
                </c:numCache>
              </c:numRef>
            </c:plus>
            <c:minus>
              <c:numRef>
                <c:f>'storage (2)'!$AN$11:$AN$14</c:f>
                <c:numCache>
                  <c:formatCode>General</c:formatCode>
                  <c:ptCount val="4"/>
                  <c:pt idx="0">
                    <c:v>0.302461313178095</c:v>
                  </c:pt>
                  <c:pt idx="1">
                    <c:v>2.877008053919877</c:v>
                  </c:pt>
                  <c:pt idx="2">
                    <c:v>0.302461313178095</c:v>
                  </c:pt>
                  <c:pt idx="3">
                    <c:v>2.8770080539198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torage (2)'!$AM$5:$AM$8</c:f>
              <c:strCache>
                <c:ptCount val="4"/>
                <c:pt idx="0">
                  <c:v>5℃</c:v>
                </c:pt>
                <c:pt idx="1">
                  <c:v>22℃</c:v>
                </c:pt>
                <c:pt idx="2">
                  <c:v>5℃ Prop</c:v>
                </c:pt>
                <c:pt idx="3">
                  <c:v>22℃ Prop</c:v>
                </c:pt>
              </c:strCache>
            </c:strRef>
          </c:cat>
          <c:val>
            <c:numRef>
              <c:f>'storage (2)'!$AN$5:$AN$8</c:f>
              <c:numCache>
                <c:formatCode>0.00</c:formatCode>
                <c:ptCount val="4"/>
                <c:pt idx="0">
                  <c:v>2.941430656934307</c:v>
                </c:pt>
                <c:pt idx="1">
                  <c:v>44.35036496350344</c:v>
                </c:pt>
                <c:pt idx="2">
                  <c:v>2.941430656934307</c:v>
                </c:pt>
                <c:pt idx="3">
                  <c:v>44.35036496350344</c:v>
                </c:pt>
              </c:numCache>
            </c:numRef>
          </c:val>
        </c:ser>
        <c:ser>
          <c:idx val="1"/>
          <c:order val="1"/>
          <c:tx>
            <c:strRef>
              <c:f>'storage (2)'!$AO$4</c:f>
              <c:strCache>
                <c:ptCount val="1"/>
                <c:pt idx="0">
                  <c:v>7 d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torage (2)'!$AO$11:$AO$14</c:f>
                <c:numCache>
                  <c:formatCode>General</c:formatCode>
                  <c:ptCount val="4"/>
                  <c:pt idx="0">
                    <c:v>0.294033936983166</c:v>
                  </c:pt>
                  <c:pt idx="1">
                    <c:v>2.151890658502063</c:v>
                  </c:pt>
                  <c:pt idx="2">
                    <c:v>0.275043563068822</c:v>
                  </c:pt>
                  <c:pt idx="3">
                    <c:v>0.142089516351257</c:v>
                  </c:pt>
                </c:numCache>
              </c:numRef>
            </c:plus>
            <c:minus>
              <c:numRef>
                <c:f>'storage (2)'!$AO$11:$AO$14</c:f>
                <c:numCache>
                  <c:formatCode>General</c:formatCode>
                  <c:ptCount val="4"/>
                  <c:pt idx="0">
                    <c:v>0.294033936983166</c:v>
                  </c:pt>
                  <c:pt idx="1">
                    <c:v>2.151890658502063</c:v>
                  </c:pt>
                  <c:pt idx="2">
                    <c:v>0.275043563068822</c:v>
                  </c:pt>
                  <c:pt idx="3">
                    <c:v>0.1420895163512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torage (2)'!$AM$5:$AM$8</c:f>
              <c:strCache>
                <c:ptCount val="4"/>
                <c:pt idx="0">
                  <c:v>5℃</c:v>
                </c:pt>
                <c:pt idx="1">
                  <c:v>22℃</c:v>
                </c:pt>
                <c:pt idx="2">
                  <c:v>5℃ Prop</c:v>
                </c:pt>
                <c:pt idx="3">
                  <c:v>22℃ Prop</c:v>
                </c:pt>
              </c:strCache>
            </c:strRef>
          </c:cat>
          <c:val>
            <c:numRef>
              <c:f>'storage (2)'!$AO$5:$AO$8</c:f>
              <c:numCache>
                <c:formatCode>0.00</c:formatCode>
                <c:ptCount val="4"/>
                <c:pt idx="0">
                  <c:v>3.032992700729928</c:v>
                </c:pt>
                <c:pt idx="1">
                  <c:v>36.79649635036496</c:v>
                </c:pt>
                <c:pt idx="2">
                  <c:v>1.688175182481752</c:v>
                </c:pt>
                <c:pt idx="3">
                  <c:v>1.877021897810219</c:v>
                </c:pt>
              </c:numCache>
            </c:numRef>
          </c:val>
        </c:ser>
        <c:ser>
          <c:idx val="2"/>
          <c:order val="2"/>
          <c:tx>
            <c:strRef>
              <c:f>'storage (2)'!$AP$4</c:f>
              <c:strCache>
                <c:ptCount val="1"/>
                <c:pt idx="0">
                  <c:v>14 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torage (2)'!$AP$11:$AP$14</c:f>
                <c:numCache>
                  <c:formatCode>General</c:formatCode>
                  <c:ptCount val="4"/>
                  <c:pt idx="0">
                    <c:v>0.108579227105344</c:v>
                  </c:pt>
                  <c:pt idx="1">
                    <c:v>3.49736370424187</c:v>
                  </c:pt>
                  <c:pt idx="2">
                    <c:v>0.275043563068822</c:v>
                  </c:pt>
                  <c:pt idx="3">
                    <c:v>0.142089516351257</c:v>
                  </c:pt>
                </c:numCache>
              </c:numRef>
            </c:plus>
            <c:minus>
              <c:numRef>
                <c:f>'storage (2)'!$AP$11:$AP$14</c:f>
                <c:numCache>
                  <c:formatCode>General</c:formatCode>
                  <c:ptCount val="4"/>
                  <c:pt idx="0">
                    <c:v>0.108579227105344</c:v>
                  </c:pt>
                  <c:pt idx="1">
                    <c:v>3.49736370424187</c:v>
                  </c:pt>
                  <c:pt idx="2">
                    <c:v>0.275043563068822</c:v>
                  </c:pt>
                  <c:pt idx="3">
                    <c:v>0.1420895163512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torage (2)'!$AM$5:$AM$8</c:f>
              <c:strCache>
                <c:ptCount val="4"/>
                <c:pt idx="0">
                  <c:v>5℃</c:v>
                </c:pt>
                <c:pt idx="1">
                  <c:v>22℃</c:v>
                </c:pt>
                <c:pt idx="2">
                  <c:v>5℃ Prop</c:v>
                </c:pt>
                <c:pt idx="3">
                  <c:v>22℃ Prop</c:v>
                </c:pt>
              </c:strCache>
            </c:strRef>
          </c:cat>
          <c:val>
            <c:numRef>
              <c:f>'storage (2)'!$AP$5:$AP$8</c:f>
              <c:numCache>
                <c:formatCode>0.00</c:formatCode>
                <c:ptCount val="4"/>
                <c:pt idx="0">
                  <c:v>3.519416058394161</c:v>
                </c:pt>
                <c:pt idx="1">
                  <c:v>39.62919708029197</c:v>
                </c:pt>
                <c:pt idx="2">
                  <c:v>1.688175182481752</c:v>
                </c:pt>
                <c:pt idx="3">
                  <c:v>1.8770218978102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86662352"/>
        <c:axId val="1886645872"/>
      </c:barChart>
      <c:catAx>
        <c:axId val="18866623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1886645872"/>
        <c:crosses val="autoZero"/>
        <c:auto val="1"/>
        <c:lblAlgn val="ctr"/>
        <c:lblOffset val="100"/>
        <c:noMultiLvlLbl val="0"/>
      </c:catAx>
      <c:valAx>
        <c:axId val="1886645872"/>
        <c:scaling>
          <c:orientation val="minMax"/>
          <c:max val="50.0"/>
          <c:min val="0.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1886662352"/>
        <c:crosses val="autoZero"/>
        <c:crossBetween val="between"/>
        <c:majorUnit val="10.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Helvetica" charset="0"/>
          <a:ea typeface="Helvetica" charset="0"/>
          <a:cs typeface="Helvetica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995188101487"/>
          <c:y val="0.0248940645296588"/>
          <c:w val="0.873206474190726"/>
          <c:h val="0.8892690878864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torage (2)'!$W$21</c:f>
              <c:strCache>
                <c:ptCount val="1"/>
                <c:pt idx="0">
                  <c:v>0 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torage (2)'!$W$28:$W$31</c:f>
                <c:numCache>
                  <c:formatCode>General</c:formatCode>
                  <c:ptCount val="4"/>
                  <c:pt idx="0">
                    <c:v>0.472628583327096</c:v>
                  </c:pt>
                  <c:pt idx="1">
                    <c:v>0.33592327166251</c:v>
                  </c:pt>
                  <c:pt idx="2">
                    <c:v>0.472628583327096</c:v>
                  </c:pt>
                  <c:pt idx="3">
                    <c:v>0.33592327166251</c:v>
                  </c:pt>
                </c:numCache>
              </c:numRef>
            </c:plus>
            <c:minus>
              <c:numRef>
                <c:f>'storage (2)'!$W$28:$W$31</c:f>
                <c:numCache>
                  <c:formatCode>General</c:formatCode>
                  <c:ptCount val="4"/>
                  <c:pt idx="0">
                    <c:v>0.472628583327096</c:v>
                  </c:pt>
                  <c:pt idx="1">
                    <c:v>0.33592327166251</c:v>
                  </c:pt>
                  <c:pt idx="2">
                    <c:v>0.472628583327096</c:v>
                  </c:pt>
                  <c:pt idx="3">
                    <c:v>0.335923271662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torage (2)'!$V$22:$V$25</c:f>
              <c:strCache>
                <c:ptCount val="4"/>
                <c:pt idx="0">
                  <c:v>5℃</c:v>
                </c:pt>
                <c:pt idx="1">
                  <c:v>22℃</c:v>
                </c:pt>
                <c:pt idx="2">
                  <c:v>5℃ Prop</c:v>
                </c:pt>
                <c:pt idx="3">
                  <c:v>22℃ Prop</c:v>
                </c:pt>
              </c:strCache>
            </c:strRef>
          </c:cat>
          <c:val>
            <c:numRef>
              <c:f>'storage (2)'!$W$22:$W$25</c:f>
              <c:numCache>
                <c:formatCode>0.00</c:formatCode>
                <c:ptCount val="4"/>
                <c:pt idx="0">
                  <c:v>14.69333333333333</c:v>
                </c:pt>
                <c:pt idx="1">
                  <c:v>16.88666666666667</c:v>
                </c:pt>
                <c:pt idx="2">
                  <c:v>14.69333333333333</c:v>
                </c:pt>
                <c:pt idx="3">
                  <c:v>16.88666666666667</c:v>
                </c:pt>
              </c:numCache>
            </c:numRef>
          </c:val>
        </c:ser>
        <c:ser>
          <c:idx val="1"/>
          <c:order val="1"/>
          <c:tx>
            <c:strRef>
              <c:f>'storage (2)'!$X$21</c:f>
              <c:strCache>
                <c:ptCount val="1"/>
                <c:pt idx="0">
                  <c:v>7 d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torage (2)'!$X$28:$X$31</c:f>
                <c:numCache>
                  <c:formatCode>General</c:formatCode>
                  <c:ptCount val="4"/>
                  <c:pt idx="0">
                    <c:v>0.43058100283222</c:v>
                  </c:pt>
                  <c:pt idx="1">
                    <c:v>0.377918274528002</c:v>
                  </c:pt>
                  <c:pt idx="2">
                    <c:v>0.374254815154951</c:v>
                  </c:pt>
                  <c:pt idx="3">
                    <c:v>0.356152277045149</c:v>
                  </c:pt>
                </c:numCache>
              </c:numRef>
            </c:plus>
            <c:minus>
              <c:numRef>
                <c:f>'storage (2)'!$X$28:$X$31</c:f>
                <c:numCache>
                  <c:formatCode>General</c:formatCode>
                  <c:ptCount val="4"/>
                  <c:pt idx="0">
                    <c:v>0.43058100283222</c:v>
                  </c:pt>
                  <c:pt idx="1">
                    <c:v>0.377918274528002</c:v>
                  </c:pt>
                  <c:pt idx="2">
                    <c:v>0.374254815154951</c:v>
                  </c:pt>
                  <c:pt idx="3">
                    <c:v>0.3561522770451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torage (2)'!$V$22:$V$25</c:f>
              <c:strCache>
                <c:ptCount val="4"/>
                <c:pt idx="0">
                  <c:v>5℃</c:v>
                </c:pt>
                <c:pt idx="1">
                  <c:v>22℃</c:v>
                </c:pt>
                <c:pt idx="2">
                  <c:v>5℃ Prop</c:v>
                </c:pt>
                <c:pt idx="3">
                  <c:v>22℃ Prop</c:v>
                </c:pt>
              </c:strCache>
            </c:strRef>
          </c:cat>
          <c:val>
            <c:numRef>
              <c:f>'storage (2)'!$X$22:$X$25</c:f>
              <c:numCache>
                <c:formatCode>0.00</c:formatCode>
                <c:ptCount val="4"/>
                <c:pt idx="0">
                  <c:v>16.21333333333316</c:v>
                </c:pt>
                <c:pt idx="1">
                  <c:v>15.90666666666667</c:v>
                </c:pt>
                <c:pt idx="2">
                  <c:v>15.28666666666667</c:v>
                </c:pt>
                <c:pt idx="3">
                  <c:v>17.12</c:v>
                </c:pt>
              </c:numCache>
            </c:numRef>
          </c:val>
        </c:ser>
        <c:ser>
          <c:idx val="2"/>
          <c:order val="2"/>
          <c:tx>
            <c:strRef>
              <c:f>'storage (2)'!$Y$21</c:f>
              <c:strCache>
                <c:ptCount val="1"/>
                <c:pt idx="0">
                  <c:v>14 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torage (2)'!$Y$28:$Y$31</c:f>
                <c:numCache>
                  <c:formatCode>General</c:formatCode>
                  <c:ptCount val="4"/>
                  <c:pt idx="0">
                    <c:v>0.424211687198214</c:v>
                  </c:pt>
                  <c:pt idx="1">
                    <c:v>1.012949488704486</c:v>
                  </c:pt>
                  <c:pt idx="2">
                    <c:v>0.374254815154951</c:v>
                  </c:pt>
                  <c:pt idx="3">
                    <c:v>0.356152277045149</c:v>
                  </c:pt>
                </c:numCache>
              </c:numRef>
            </c:plus>
            <c:minus>
              <c:numRef>
                <c:f>'storage (2)'!$Y$28:$Y$31</c:f>
                <c:numCache>
                  <c:formatCode>General</c:formatCode>
                  <c:ptCount val="4"/>
                  <c:pt idx="0">
                    <c:v>0.424211687198214</c:v>
                  </c:pt>
                  <c:pt idx="1">
                    <c:v>1.012949488704486</c:v>
                  </c:pt>
                  <c:pt idx="2">
                    <c:v>0.374254815154951</c:v>
                  </c:pt>
                  <c:pt idx="3">
                    <c:v>0.3561522770451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torage (2)'!$V$22:$V$25</c:f>
              <c:strCache>
                <c:ptCount val="4"/>
                <c:pt idx="0">
                  <c:v>5℃</c:v>
                </c:pt>
                <c:pt idx="1">
                  <c:v>22℃</c:v>
                </c:pt>
                <c:pt idx="2">
                  <c:v>5℃ Prop</c:v>
                </c:pt>
                <c:pt idx="3">
                  <c:v>22℃ Prop</c:v>
                </c:pt>
              </c:strCache>
            </c:strRef>
          </c:cat>
          <c:val>
            <c:numRef>
              <c:f>'storage (2)'!$Y$22:$Y$25</c:f>
              <c:numCache>
                <c:formatCode>0.00</c:formatCode>
                <c:ptCount val="4"/>
                <c:pt idx="0">
                  <c:v>15.48666666666667</c:v>
                </c:pt>
                <c:pt idx="1">
                  <c:v>16.05333333333316</c:v>
                </c:pt>
                <c:pt idx="2">
                  <c:v>15.28666666666667</c:v>
                </c:pt>
                <c:pt idx="3">
                  <c:v>17.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913810160"/>
        <c:axId val="1881383680"/>
      </c:barChart>
      <c:catAx>
        <c:axId val="1913810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1881383680"/>
        <c:crosses val="autoZero"/>
        <c:auto val="1"/>
        <c:lblAlgn val="ctr"/>
        <c:lblOffset val="100"/>
        <c:noMultiLvlLbl val="0"/>
      </c:catAx>
      <c:valAx>
        <c:axId val="1881383680"/>
        <c:scaling>
          <c:orientation val="minMax"/>
          <c:max val="20.0"/>
          <c:min val="0.0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1913810160"/>
        <c:crosses val="autoZero"/>
        <c:crossBetween val="between"/>
        <c:majorUnit val="5.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Helvetica" charset="0"/>
          <a:ea typeface="Helvetica" charset="0"/>
          <a:cs typeface="Helvetica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869420384951881"/>
          <c:y val="0.0254283318751823"/>
          <c:w val="0.876946850393701"/>
          <c:h val="0.9401896115298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P$4</c:f>
              <c:strCache>
                <c:ptCount val="1"/>
                <c:pt idx="0">
                  <c:v>0 d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O$5:$O$8</c:f>
              <c:strCache>
                <c:ptCount val="4"/>
                <c:pt idx="0">
                  <c:v>5℃</c:v>
                </c:pt>
                <c:pt idx="1">
                  <c:v>22℃</c:v>
                </c:pt>
                <c:pt idx="2">
                  <c:v>5℃ Prop</c:v>
                </c:pt>
                <c:pt idx="3">
                  <c:v>22℃ Prop</c:v>
                </c:pt>
              </c:strCache>
            </c:strRef>
          </c:cat>
          <c:val>
            <c:numRef>
              <c:f>Sheet1!$P$5:$P$8</c:f>
              <c:numCache>
                <c:formatCode>0.0000</c:formatCode>
                <c:ptCount val="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Q$4</c:f>
              <c:strCache>
                <c:ptCount val="1"/>
                <c:pt idx="0">
                  <c:v>7 d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Q$11:$Q$14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0</c:v>
                  </c:pt>
                  <c:pt idx="2">
                    <c:v>0.00428744650545961</c:v>
                  </c:pt>
                  <c:pt idx="3">
                    <c:v>0.00135711178191571</c:v>
                  </c:pt>
                </c:numCache>
              </c:numRef>
            </c:plus>
            <c:minus>
              <c:numRef>
                <c:f>Sheet1!$Q$11:$Q$14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0</c:v>
                  </c:pt>
                  <c:pt idx="2">
                    <c:v>0.00428744650545961</c:v>
                  </c:pt>
                  <c:pt idx="3">
                    <c:v>0.001357111781915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O$5:$O$8</c:f>
              <c:strCache>
                <c:ptCount val="4"/>
                <c:pt idx="0">
                  <c:v>5℃</c:v>
                </c:pt>
                <c:pt idx="1">
                  <c:v>22℃</c:v>
                </c:pt>
                <c:pt idx="2">
                  <c:v>5℃ Prop</c:v>
                </c:pt>
                <c:pt idx="3">
                  <c:v>22℃ Prop</c:v>
                </c:pt>
              </c:strCache>
            </c:strRef>
          </c:cat>
          <c:val>
            <c:numRef>
              <c:f>Sheet1!$Q$5:$Q$8</c:f>
              <c:numCache>
                <c:formatCode>0.0000</c:formatCode>
                <c:ptCount val="4"/>
                <c:pt idx="0">
                  <c:v>0.0</c:v>
                </c:pt>
                <c:pt idx="1">
                  <c:v>0.0</c:v>
                </c:pt>
                <c:pt idx="2">
                  <c:v>0.0264465183163874</c:v>
                </c:pt>
                <c:pt idx="3">
                  <c:v>0.00399331391677482</c:v>
                </c:pt>
              </c:numCache>
            </c:numRef>
          </c:val>
        </c:ser>
        <c:ser>
          <c:idx val="2"/>
          <c:order val="2"/>
          <c:tx>
            <c:strRef>
              <c:f>Sheet1!$R$4</c:f>
              <c:strCache>
                <c:ptCount val="1"/>
                <c:pt idx="0">
                  <c:v>14 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R$11:$R$14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0</c:v>
                  </c:pt>
                  <c:pt idx="2">
                    <c:v>0.00801607595617858</c:v>
                  </c:pt>
                  <c:pt idx="3">
                    <c:v>0.0114899135942837</c:v>
                  </c:pt>
                </c:numCache>
              </c:numRef>
            </c:plus>
            <c:minus>
              <c:numRef>
                <c:f>Sheet1!$R$11:$R$14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0</c:v>
                  </c:pt>
                  <c:pt idx="2">
                    <c:v>0.00801607595617858</c:v>
                  </c:pt>
                  <c:pt idx="3">
                    <c:v>0.01148991359428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O$5:$O$8</c:f>
              <c:strCache>
                <c:ptCount val="4"/>
                <c:pt idx="0">
                  <c:v>5℃</c:v>
                </c:pt>
                <c:pt idx="1">
                  <c:v>22℃</c:v>
                </c:pt>
                <c:pt idx="2">
                  <c:v>5℃ Prop</c:v>
                </c:pt>
                <c:pt idx="3">
                  <c:v>22℃ Prop</c:v>
                </c:pt>
              </c:strCache>
            </c:strRef>
          </c:cat>
          <c:val>
            <c:numRef>
              <c:f>Sheet1!$R$5:$R$8</c:f>
              <c:numCache>
                <c:formatCode>0.0000</c:formatCode>
                <c:ptCount val="4"/>
                <c:pt idx="0">
                  <c:v>0.0</c:v>
                </c:pt>
                <c:pt idx="1">
                  <c:v>0.0</c:v>
                </c:pt>
                <c:pt idx="2">
                  <c:v>0.0361558313267552</c:v>
                </c:pt>
                <c:pt idx="3">
                  <c:v>0.02436522002104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82356864"/>
        <c:axId val="1882435936"/>
      </c:barChart>
      <c:catAx>
        <c:axId val="1882356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1882435936"/>
        <c:crosses val="autoZero"/>
        <c:auto val="1"/>
        <c:lblAlgn val="ctr"/>
        <c:lblOffset val="100"/>
        <c:noMultiLvlLbl val="0"/>
      </c:catAx>
      <c:valAx>
        <c:axId val="1882435936"/>
        <c:scaling>
          <c:orientation val="minMax"/>
          <c:max val="0.055"/>
          <c:min val="0.0"/>
        </c:scaling>
        <c:delete val="0"/>
        <c:axPos val="l"/>
        <c:numFmt formatCode="#,##0.0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1882356864"/>
        <c:crosses val="autoZero"/>
        <c:crossBetween val="between"/>
        <c:majorUnit val="0.01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205485783027122"/>
          <c:y val="0.358910643740798"/>
          <c:w val="0.37236154855643"/>
          <c:h val="0.3275267346329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Helvetica" charset="0"/>
              <a:ea typeface="Helvetica" charset="0"/>
              <a:cs typeface="Helvetica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Helvetica" charset="0"/>
          <a:ea typeface="Helvetica" charset="0"/>
          <a:cs typeface="Helvetica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82A022-C9F4-0148-975C-F94539B6FB3D}" type="datetimeFigureOut">
              <a:rPr lang="en-US" smtClean="0"/>
              <a:t>2/15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F2F5C-3AD8-114A-9235-54C4AB861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31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3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/>
          <p:cNvGrpSpPr/>
          <p:nvPr/>
        </p:nvGrpSpPr>
        <p:grpSpPr>
          <a:xfrm>
            <a:off x="977900" y="518386"/>
            <a:ext cx="8440150" cy="9971098"/>
            <a:chOff x="977900" y="518386"/>
            <a:chExt cx="8440150" cy="9971098"/>
          </a:xfrm>
        </p:grpSpPr>
        <p:grpSp>
          <p:nvGrpSpPr>
            <p:cNvPr id="11" name="Group 10"/>
            <p:cNvGrpSpPr/>
            <p:nvPr/>
          </p:nvGrpSpPr>
          <p:grpSpPr>
            <a:xfrm>
              <a:off x="977900" y="518386"/>
              <a:ext cx="8440150" cy="9971098"/>
              <a:chOff x="977900" y="518386"/>
              <a:chExt cx="8440150" cy="9971098"/>
            </a:xfrm>
          </p:grpSpPr>
          <p:grpSp>
            <p:nvGrpSpPr>
              <p:cNvPr id="9" name="Group 8"/>
              <p:cNvGrpSpPr/>
              <p:nvPr/>
            </p:nvGrpSpPr>
            <p:grpSpPr>
              <a:xfrm>
                <a:off x="1933772" y="518386"/>
                <a:ext cx="4905178" cy="9165501"/>
                <a:chOff x="1933772" y="518386"/>
                <a:chExt cx="4905178" cy="9165501"/>
              </a:xfrm>
            </p:grpSpPr>
            <p:graphicFrame>
              <p:nvGraphicFramePr>
                <p:cNvPr id="2" name="Chart 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801348629"/>
                    </p:ext>
                  </p:extLst>
                </p:nvPr>
              </p:nvGraphicFramePr>
              <p:xfrm>
                <a:off x="2266950" y="3220312"/>
                <a:ext cx="4572000" cy="287106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3" name="Chart 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338471622"/>
                    </p:ext>
                  </p:extLst>
                </p:nvPr>
              </p:nvGraphicFramePr>
              <p:xfrm>
                <a:off x="2266950" y="6120282"/>
                <a:ext cx="4572000" cy="322691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4" name="Chart 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3084934"/>
                    </p:ext>
                  </p:extLst>
                </p:nvPr>
              </p:nvGraphicFramePr>
              <p:xfrm>
                <a:off x="2254250" y="518386"/>
                <a:ext cx="4572000" cy="270192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5" name="TextBox 4"/>
                <p:cNvSpPr txBox="1"/>
                <p:nvPr/>
              </p:nvSpPr>
              <p:spPr>
                <a:xfrm rot="16200000">
                  <a:off x="1138376" y="1715460"/>
                  <a:ext cx="189857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b="1" smtClean="0">
                      <a:latin typeface="Helvetica" charset="0"/>
                      <a:ea typeface="Helvetica" charset="0"/>
                      <a:cs typeface="Helvetica" charset="0"/>
                    </a:rPr>
                    <a:t>Ethylene (nLg</a:t>
                  </a:r>
                  <a:r>
                    <a:rPr lang="en-US" sz="1400" b="1" baseline="30000" smtClean="0">
                      <a:latin typeface="Helvetica" charset="0"/>
                      <a:ea typeface="Helvetica" charset="0"/>
                      <a:cs typeface="Helvetica" charset="0"/>
                    </a:rPr>
                    <a:t>-1</a:t>
                  </a:r>
                  <a:r>
                    <a:rPr lang="en-US" sz="1400" b="1" smtClean="0">
                      <a:latin typeface="Helvetica" charset="0"/>
                      <a:ea typeface="Helvetica" charset="0"/>
                      <a:cs typeface="Helvetica" charset="0"/>
                    </a:rPr>
                    <a:t>h</a:t>
                  </a:r>
                  <a:r>
                    <a:rPr lang="en-US" sz="1400" b="1" baseline="30000" smtClean="0">
                      <a:latin typeface="Helvetica" charset="0"/>
                      <a:ea typeface="Helvetica" charset="0"/>
                      <a:cs typeface="Helvetica" charset="0"/>
                    </a:rPr>
                    <a:t>-1</a:t>
                  </a:r>
                  <a:r>
                    <a:rPr lang="en-US" sz="1400" b="1" dirty="0" smtClean="0">
                      <a:latin typeface="Helvetica" charset="0"/>
                      <a:ea typeface="Helvetica" charset="0"/>
                      <a:cs typeface="Helvetica" charset="0"/>
                    </a:rPr>
                    <a:t>)</a:t>
                  </a:r>
                  <a:endParaRPr lang="en-US" sz="1400" b="1" dirty="0">
                    <a:latin typeface="Helvetica" charset="0"/>
                    <a:ea typeface="Helvetica" charset="0"/>
                    <a:cs typeface="Helvetica" charset="0"/>
                  </a:endParaRP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 rot="16200000">
                  <a:off x="1443175" y="4501953"/>
                  <a:ext cx="128897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b="1" smtClean="0">
                      <a:latin typeface="Helvetica" charset="0"/>
                      <a:ea typeface="Helvetica" charset="0"/>
                      <a:cs typeface="Helvetica" charset="0"/>
                    </a:rPr>
                    <a:t>Firmness (N)</a:t>
                  </a:r>
                  <a:endParaRPr lang="en-US" sz="1400" b="1" dirty="0">
                    <a:latin typeface="Helvetica" charset="0"/>
                    <a:ea typeface="Helvetica" charset="0"/>
                    <a:cs typeface="Helvetica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 rot="16200000">
                  <a:off x="1614625" y="7579852"/>
                  <a:ext cx="94607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b="1" smtClean="0">
                      <a:latin typeface="Helvetica" charset="0"/>
                      <a:ea typeface="Helvetica" charset="0"/>
                      <a:cs typeface="Helvetica" charset="0"/>
                    </a:rPr>
                    <a:t>SSC (%)</a:t>
                  </a:r>
                  <a:endParaRPr lang="en-US" sz="1400" b="1" dirty="0">
                    <a:latin typeface="Helvetica" charset="0"/>
                    <a:ea typeface="Helvetica" charset="0"/>
                    <a:cs typeface="Helvetica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4053306" y="9376110"/>
                  <a:ext cx="135488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b="1" smtClean="0">
                      <a:latin typeface="Helvetica" charset="0"/>
                      <a:ea typeface="Helvetica" charset="0"/>
                      <a:cs typeface="Helvetica" charset="0"/>
                    </a:rPr>
                    <a:t>Treatments</a:t>
                  </a:r>
                  <a:endParaRPr lang="en-US" sz="1400" b="1" dirty="0">
                    <a:latin typeface="Helvetica" charset="0"/>
                    <a:ea typeface="Helvetica" charset="0"/>
                    <a:cs typeface="Helvetica" charset="0"/>
                  </a:endParaRPr>
                </a:p>
              </p:txBody>
            </p:sp>
          </p:grpSp>
          <p:sp>
            <p:nvSpPr>
              <p:cNvPr id="10" name="TextBox 9"/>
              <p:cNvSpPr txBox="1"/>
              <p:nvPr/>
            </p:nvSpPr>
            <p:spPr>
              <a:xfrm>
                <a:off x="977900" y="9658487"/>
                <a:ext cx="8440150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Supplementary Figure </a:t>
                </a:r>
                <a:r>
                  <a:rPr lang="en-US" sz="1200" b="1" dirty="0">
                    <a:latin typeface="Times New Roman" charset="0"/>
                    <a:ea typeface="Times New Roman" charset="0"/>
                    <a:cs typeface="Times New Roman" charset="0"/>
                  </a:rPr>
                  <a:t>3</a:t>
                </a:r>
                <a:r>
                  <a:rPr lang="en-US" sz="12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. Changes in ethylene production rate, firmness and SSC of ‘</a:t>
                </a:r>
                <a:r>
                  <a:rPr lang="en-US" sz="1200" b="1" dirty="0" err="1" smtClean="0">
                    <a:latin typeface="Times New Roman" charset="0"/>
                    <a:ea typeface="Times New Roman" charset="0"/>
                    <a:cs typeface="Times New Roman" charset="0"/>
                  </a:rPr>
                  <a:t>Kosui</a:t>
                </a:r>
                <a:r>
                  <a:rPr lang="en-US" sz="12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’ kiwifruit used for aroma volatile analysis. </a:t>
                </a:r>
                <a:r>
                  <a:rPr lang="en-US" sz="1200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After 49 d storage </a:t>
                </a:r>
                <a:r>
                  <a:rPr lang="en-US" sz="1200" dirty="0">
                    <a:latin typeface="Times New Roman" charset="0"/>
                    <a:ea typeface="Times New Roman" charset="0"/>
                    <a:cs typeface="Times New Roman" charset="0"/>
                  </a:rPr>
                  <a:t>p</a:t>
                </a:r>
                <a:r>
                  <a:rPr lang="en-US" sz="1200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eriod, all fruit were held at 22℃ with or without propylene treatment</a:t>
                </a:r>
                <a:r>
                  <a:rPr lang="en-US" sz="12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. </a:t>
                </a:r>
                <a:r>
                  <a:rPr lang="en-US" sz="1200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Black, gray and white bars represent 0, 7 and 14 days post-storage.</a:t>
                </a:r>
                <a:r>
                  <a:rPr lang="en-US" sz="1200" b="1" dirty="0">
                    <a:latin typeface="Times New Roman" charset="0"/>
                    <a:ea typeface="Times New Roman" charset="0"/>
                    <a:cs typeface="Times New Roman" charset="0"/>
                  </a:rPr>
                  <a:t> </a:t>
                </a:r>
                <a:r>
                  <a:rPr lang="en-US" sz="1200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Data </a:t>
                </a:r>
                <a:r>
                  <a:rPr lang="en-US" sz="1200" dirty="0">
                    <a:latin typeface="Times New Roman" charset="0"/>
                    <a:ea typeface="Times New Roman" charset="0"/>
                    <a:cs typeface="Times New Roman" charset="0"/>
                  </a:rPr>
                  <a:t>are mean (±SE) of </a:t>
                </a:r>
                <a:r>
                  <a:rPr lang="en-US" sz="1200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five independent </a:t>
                </a:r>
                <a:r>
                  <a:rPr lang="en-US" sz="1200" dirty="0">
                    <a:latin typeface="Times New Roman" charset="0"/>
                    <a:ea typeface="Times New Roman" charset="0"/>
                    <a:cs typeface="Times New Roman" charset="0"/>
                  </a:rPr>
                  <a:t>biological replications. Error bars not shown are smaller than the symbol used. Different letters indicate significant differences in ANOVA (Tukey test, p &lt; 0.05</a:t>
                </a:r>
                <a:r>
                  <a:rPr lang="en-US" sz="1200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).</a:t>
                </a:r>
                <a:endParaRPr lang="en-US" sz="1200" b="1" dirty="0">
                  <a:latin typeface="Times New Roman" charset="0"/>
                  <a:ea typeface="Times New Roman" charset="0"/>
                  <a:cs typeface="Times New Roman" charset="0"/>
                </a:endParaRPr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2870200" y="5613574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124201" y="5600874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378202" y="5588174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870200" y="2912726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124201" y="2901171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378202" y="2901171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129506" y="3692809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875506" y="3245712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381500" y="3471988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875506" y="2903421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129506" y="2912612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391024" y="2906363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892800" y="3251167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892800" y="2901171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134100" y="2675504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375400" y="1278414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159500" y="5676017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143502" y="5673184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382793" y="5673183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889501" y="5608007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400800" y="5674674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884153" y="2902203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charset="0"/>
                  <a:ea typeface="Helvetica" charset="0"/>
                  <a:cs typeface="Helvetica" charset="0"/>
                </a:rPr>
                <a:t>b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130802" y="1512718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370093" y="905422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390903" y="6566606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149602" y="6481595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895601" y="6677016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894556" y="6387487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140204" y="6522145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4403725" y="6415622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886325" y="6664292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400679" y="6617406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143502" y="6609601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892800" y="6381413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378575" y="6344319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134100" y="6350680"/>
              <a:ext cx="190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Helvetica" charset="0"/>
                  <a:ea typeface="Helvetica" charset="0"/>
                  <a:cs typeface="Helvetica" charset="0"/>
                </a:rPr>
                <a:t>a</a:t>
              </a:r>
              <a:endParaRPr lang="en-US" sz="1000">
                <a:latin typeface="Helvetica" charset="0"/>
                <a:ea typeface="Helvetica" charset="0"/>
                <a:cs typeface="Helvetica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566483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25</TotalTime>
  <Words>143</Words>
  <Application>Microsoft Macintosh PowerPoint</Application>
  <PresentationFormat>A3 Paper (297x420 mm)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TALO Oscar　Witere</dc:creator>
  <cp:lastModifiedBy>MITALO Oscar　Witere</cp:lastModifiedBy>
  <cp:revision>908</cp:revision>
  <dcterms:created xsi:type="dcterms:W3CDTF">2018-04-12T04:09:11Z</dcterms:created>
  <dcterms:modified xsi:type="dcterms:W3CDTF">2019-02-15T02:41:08Z</dcterms:modified>
</cp:coreProperties>
</file>